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hana" initials="J" lastIdx="2" clrIdx="0">
    <p:extLst>
      <p:ext uri="{19B8F6BF-5375-455C-9EA6-DF929625EA0E}">
        <p15:presenceInfo xmlns:p15="http://schemas.microsoft.com/office/powerpoint/2012/main" userId="Johana" providerId="None"/>
      </p:ext>
    </p:extLst>
  </p:cmAuthor>
  <p:cmAuthor id="2" name="Weinhäusel Andreas" initials="WA" lastIdx="2" clrIdx="1">
    <p:extLst>
      <p:ext uri="{19B8F6BF-5375-455C-9EA6-DF929625EA0E}">
        <p15:presenceInfo xmlns:p15="http://schemas.microsoft.com/office/powerpoint/2012/main" userId="Weinhäusel Andrea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10" d="100"/>
          <a:sy n="110" d="100"/>
        </p:scale>
        <p:origin x="1602" y="-22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3036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3879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8636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7971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9988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4704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2557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0321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8877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8182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026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802A2-3B99-4EB3-91F1-72C98868CF87}" type="datetimeFigureOut">
              <a:rPr lang="en-GB" smtClean="0"/>
              <a:t>21/02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FAF97E-DDC8-43A9-B81E-2E06A085AD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1492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1" descr="C:\Users\WeinhaeuselA\Desktop\ANDIS_BRB\20151116_CompetitionMixing_16k\20151116_CompetitionMixing_16k -Project\Output\ClassComparison2\VolcanoPlot.png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1" t="10409" r="4465" b="5898"/>
          <a:stretch/>
        </p:blipFill>
        <p:spPr bwMode="auto">
          <a:xfrm>
            <a:off x="1495553" y="2368826"/>
            <a:ext cx="2762503" cy="1730853"/>
          </a:xfrm>
          <a:prstGeom prst="rect">
            <a:avLst/>
          </a:prstGeom>
          <a:noFill/>
          <a:ln>
            <a:noFill/>
          </a:ln>
        </p:spPr>
      </p:pic>
      <p:sp>
        <p:nvSpPr>
          <p:cNvPr id="11" name="Titel 1"/>
          <p:cNvSpPr txBox="1">
            <a:spLocks/>
          </p:cNvSpPr>
          <p:nvPr/>
        </p:nvSpPr>
        <p:spPr bwMode="auto">
          <a:xfrm>
            <a:off x="350658" y="248402"/>
            <a:ext cx="6057900" cy="526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rgbClr val="A50021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rgbClr val="A50021"/>
                </a:solidFill>
                <a:latin typeface="Arial Narrow" pitchFamily="34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rgbClr val="A50021"/>
                </a:solidFill>
                <a:latin typeface="Arial Narrow" pitchFamily="34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rgbClr val="A50021"/>
                </a:solidFill>
                <a:latin typeface="Arial Narrow" pitchFamily="34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3200">
                <a:solidFill>
                  <a:srgbClr val="A50021"/>
                </a:solidFill>
                <a:latin typeface="Arial Narrow" pitchFamily="34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3200">
                <a:solidFill>
                  <a:srgbClr val="A50021"/>
                </a:solidFill>
                <a:latin typeface="Arial Narrow" pitchFamily="34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3200">
                <a:solidFill>
                  <a:srgbClr val="A50021"/>
                </a:solidFill>
                <a:latin typeface="Arial Narrow" pitchFamily="34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3200">
                <a:solidFill>
                  <a:srgbClr val="A50021"/>
                </a:solidFill>
                <a:latin typeface="Arial Narrow" pitchFamily="34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3200">
                <a:solidFill>
                  <a:srgbClr val="A50021"/>
                </a:solidFill>
                <a:latin typeface="Arial Narrow" pitchFamily="34" charset="0"/>
              </a:defRPr>
            </a:lvl9pPr>
          </a:lstStyle>
          <a:p>
            <a:pPr defTabSz="685800">
              <a:defRPr/>
            </a:pPr>
            <a:endParaRPr lang="de-AT" sz="2400" kern="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Inhaltsplatzhalter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4746011"/>
              </p:ext>
            </p:extLst>
          </p:nvPr>
        </p:nvGraphicFramePr>
        <p:xfrm>
          <a:off x="1342288" y="726305"/>
          <a:ext cx="3028134" cy="1170148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53501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86042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5641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7627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14287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x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 1 (%)</a:t>
                      </a:r>
                      <a:endParaRPr lang="en-US" sz="105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 2 (%)</a:t>
                      </a:r>
                      <a:endParaRPr lang="en-US" sz="1050" b="1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licates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287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050" b="1" i="0" u="none" strike="noStrike" noProof="0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50" b="1" i="0" u="none" strike="noStrike" noProof="0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4287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sz="1050" b="1" i="0" u="none" strike="noStrike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  <a:endParaRPr lang="en-US" sz="1050" b="1" i="0" u="none" strike="noStrike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4287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sz="1050" b="1" i="0" u="none" strike="noStrike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</a:t>
                      </a:r>
                      <a:endParaRPr lang="en-US" sz="1050" b="1" i="0" u="none" strike="noStrike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4287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5</a:t>
                      </a:r>
                      <a:endParaRPr lang="en-US" sz="1050" b="1" i="0" u="none" strike="noStrike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.5</a:t>
                      </a:r>
                      <a:endParaRPr lang="en-US" sz="1050" b="1" i="0" u="none" strike="noStrike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4287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5</a:t>
                      </a:r>
                      <a:endParaRPr lang="en-US" sz="1050" b="1" i="0" u="none" strike="noStrike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75</a:t>
                      </a:r>
                      <a:endParaRPr lang="en-US" sz="1050" b="1" i="0" u="none" strike="noStrike" noProof="0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42875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50" b="1" i="0" u="none" strike="noStrike" noProof="0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US" sz="1050" b="1" i="0" u="none" strike="noStrike" noProof="0" dirty="0">
                        <a:solidFill>
                          <a:srgbClr val="0000FF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dk1"/>
                          </a:solidFill>
                          <a:latin typeface="Arial Narrow"/>
                        </a:defRPr>
                      </a:lvl9pPr>
                    </a:lstStyle>
                    <a:p>
                      <a:pPr algn="ctr" fontAlgn="ctr"/>
                      <a:r>
                        <a:rPr lang="en-US" sz="1050" u="none" strike="noStrike" noProof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50" b="0" i="0" u="none" strike="noStrike" noProof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44" marR="7144" marT="7144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pic>
        <p:nvPicPr>
          <p:cNvPr id="15" name="Grafik 14"/>
          <p:cNvPicPr/>
          <p:nvPr/>
        </p:nvPicPr>
        <p:blipFill rotWithShape="1">
          <a:blip r:embed="rId3"/>
          <a:srcRect l="5008" t="19565" r="6311" b="13520"/>
          <a:stretch/>
        </p:blipFill>
        <p:spPr>
          <a:xfrm>
            <a:off x="1452829" y="4655977"/>
            <a:ext cx="2683934" cy="16764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 rot="16200000">
            <a:off x="486898" y="2993063"/>
            <a:ext cx="1326972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1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alue)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19522" y="547585"/>
            <a:ext cx="4245740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US" sz="825" b="1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                    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19522" y="2192351"/>
            <a:ext cx="4245740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" dirty="0">
                <a:latin typeface="Arial" panose="020B0604020202020204" pitchFamily="34" charset="0"/>
                <a:cs typeface="Arial" panose="020B0604020202020204" pitchFamily="34" charset="0"/>
              </a:rPr>
              <a:t>           </a:t>
            </a:r>
            <a:r>
              <a:rPr lang="en-US" sz="825" b="1" dirty="0">
                <a:latin typeface="Arial" panose="020B0604020202020204" pitchFamily="34" charset="0"/>
                <a:cs typeface="Arial" panose="020B0604020202020204" pitchFamily="34" charset="0"/>
              </a:rPr>
              <a:t>B                                                                                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19522" y="4528584"/>
            <a:ext cx="4245740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450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US" sz="825" b="1" dirty="0">
                <a:latin typeface="Arial" panose="020B0604020202020204" pitchFamily="34" charset="0"/>
                <a:cs typeface="Arial" panose="020B0604020202020204" pitchFamily="34" charset="0"/>
              </a:rPr>
              <a:t>C                                                                                 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215620" y="4207483"/>
            <a:ext cx="14713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1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fold change)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557961" y="5171721"/>
            <a:ext cx="119562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875229" y="6411991"/>
            <a:ext cx="21290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earson correlation coefficient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559173" y="4000664"/>
            <a:ext cx="274906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-4                    -2                    0                     2                    4 </a:t>
            </a:r>
            <a:endParaRPr 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559173" y="6146659"/>
            <a:ext cx="3212123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-1                -0.5                  0                  0.5                  1 </a:t>
            </a:r>
            <a:endParaRPr lang="en-US" sz="7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399249" y="2318938"/>
            <a:ext cx="195128" cy="1733808"/>
          </a:xfrm>
          <a:prstGeom prst="rect">
            <a:avLst/>
          </a:prstGeom>
          <a:solidFill>
            <a:schemeClr val="bg1"/>
          </a:solidFill>
        </p:spPr>
        <p:txBody>
          <a:bodyPr vert="horz" wrap="square" rtlCol="0">
            <a:spAutoFit/>
          </a:bodyPr>
          <a:lstStyle/>
          <a:p>
            <a:pPr algn="just">
              <a:spcBef>
                <a:spcPts val="8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  <a:p>
            <a:pPr algn="just">
              <a:spcBef>
                <a:spcPts val="8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  <a:p>
            <a:pPr algn="just">
              <a:spcBef>
                <a:spcPts val="8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pPr algn="just">
              <a:spcBef>
                <a:spcPts val="8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  <a:p>
            <a:pPr algn="just">
              <a:spcBef>
                <a:spcPts val="8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pPr algn="just">
              <a:spcBef>
                <a:spcPts val="8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just">
              <a:spcBef>
                <a:spcPts val="8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just">
              <a:spcBef>
                <a:spcPts val="8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785338" y="5330293"/>
            <a:ext cx="1420430" cy="20774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0         100        200        300 </a:t>
            </a:r>
            <a:endParaRPr 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Straight Connector 3"/>
          <p:cNvCxnSpPr/>
          <p:nvPr/>
        </p:nvCxnSpPr>
        <p:spPr>
          <a:xfrm>
            <a:off x="1627818" y="2371454"/>
            <a:ext cx="0" cy="1592856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1633858" y="3970938"/>
            <a:ext cx="2624198" cy="0"/>
          </a:xfrm>
          <a:prstGeom prst="line">
            <a:avLst/>
          </a:prstGeom>
          <a:ln w="19050"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0"/>
          <p:cNvSpPr txBox="1"/>
          <p:nvPr/>
        </p:nvSpPr>
        <p:spPr>
          <a:xfrm>
            <a:off x="1242781" y="4823220"/>
            <a:ext cx="357312" cy="1323439"/>
          </a:xfrm>
          <a:prstGeom prst="rect">
            <a:avLst/>
          </a:prstGeom>
          <a:solidFill>
            <a:schemeClr val="bg1"/>
          </a:solidFill>
        </p:spPr>
        <p:txBody>
          <a:bodyPr vert="horz" wrap="square" rIns="0" rtlCol="0">
            <a:spAutoFit/>
          </a:bodyPr>
          <a:lstStyle/>
          <a:p>
            <a:pPr algn="r">
              <a:spcBef>
                <a:spcPts val="20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</a:p>
          <a:p>
            <a:pPr algn="r">
              <a:spcBef>
                <a:spcPts val="20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  <a:p>
            <a:pPr algn="r">
              <a:spcBef>
                <a:spcPts val="20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spcBef>
                <a:spcPts val="2000"/>
              </a:spcBef>
            </a:pPr>
            <a:r>
              <a:rPr lang="en-US" sz="75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22726889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81</Words>
  <Application>Microsoft Office PowerPoint</Application>
  <PresentationFormat>全屏显示(4:3)</PresentationFormat>
  <Paragraphs>5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hana Luna</dc:creator>
  <cp:lastModifiedBy>A</cp:lastModifiedBy>
  <cp:revision>23</cp:revision>
  <dcterms:created xsi:type="dcterms:W3CDTF">2017-09-27T19:05:30Z</dcterms:created>
  <dcterms:modified xsi:type="dcterms:W3CDTF">2018-02-20T18:31:54Z</dcterms:modified>
</cp:coreProperties>
</file>